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22" d="100"/>
          <a:sy n="122" d="100"/>
        </p:scale>
        <p:origin x="1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DA61D9-BA55-FE35-A7E8-E87BEDFCD7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023755-DAEC-4F0F-AFED-B6791988DA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322B4B-34B3-809A-2AD5-F40F70D03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7DB233-0389-E523-60F1-D0A984372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552598-3A99-E9C7-AD0F-905DCFA782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709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C1FBEA-60FC-E717-A6F4-216E13F90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414D70-D9B0-8C9A-8A08-4614C77484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12DF3C-0897-52BA-15CE-0ED22B57E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8BE52C-355F-014C-2DC2-5B7AF5570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AC68C7-83EF-E011-5516-EEE0AD94B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78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86EC4D-B6EE-84D8-E51E-189190D86C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AA2419-6766-1A2A-9890-8260D85C06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6B50B1-E278-1227-31ED-DE7BD53E3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7F5227-40BC-63C3-CB74-1910025558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7EEDE3-A3DE-D692-95E5-779489171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901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7979EE-4EA3-4AA6-D715-8C24FE8AE0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BA1964-C0F1-2B72-E167-BB177BEEC7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135E53-D974-7F77-2F90-2FD28E771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944146-604F-FB38-4425-EAD2AA05D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EC7AA1-70B8-A2A6-6062-BBFD4AF84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133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581304-5BAC-4B5A-0FB4-E59C98E483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F4235D-6467-0F1B-1D78-AB7E7F2FEC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BADD1A-F75C-C821-5857-3450E55CF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AD49BA-2CCA-6B39-6B7E-889938320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1B8CB7-B830-8644-2B3D-906D517CA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5823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518741-4E95-892F-6240-6CBAE1EE52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6D08F4-EE8D-0A74-CDE6-9357766220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A579B4-5BDD-E543-3014-E47EED0EBB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212F1A-274C-F0DC-9CAA-BEE9E4922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5E535F-D99A-052F-191C-71AF73ACE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AD0BDB-90C1-DFB6-3708-50BD5DC80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973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1E75D9-9A18-6E76-C145-1C4F71620B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7C471A-0D2E-D7C1-C234-A8125AA0CA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BD9DA7-47E5-F98E-0F19-3845AA6C16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85304C3-6945-56E4-7BEE-EB3E6C6B2A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3E0FD7-5F33-814F-0B28-C71FC9C096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713599-DAF5-8E7F-0AF6-A9ECACCC9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EB8552-7B11-E73E-48C4-A34C2604E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52C44E-B570-A93C-C93D-59575D5F6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03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367ADE-3ACF-0DCA-98BE-47F12BC007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40EEEA4-1205-5DD6-CF55-D14131F2D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2A2C7D-D9C7-3296-1E35-BBD75FE10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798E291-0827-C9E5-D2B0-1CFE4B176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254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D5E948-E8AC-BB1A-2A02-229794C9C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4DC698-5B06-B8A7-DB68-19884C12F7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C050E4A-6C99-EF63-9BEE-73CFB4419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543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E7827E-2839-C0B1-3443-4403231E74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2BB813-1EE4-081D-94DD-620745F501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0104F3-392B-3136-91F4-451DE60E46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084CA2-22DA-7097-E969-A59765E99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42267A-9023-DC92-243B-3533580E5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431003-CFD3-BFD7-D8C9-8D4F46D026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620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B55C40-F776-CB84-F16E-D60D6EAD1D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B3C3FA7-9C2C-9DE7-0ACA-A80C8AC932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FC5BD3-6FCE-2231-CA87-6639FBFFBD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922347-25FE-BDF0-52F6-0AB3B8CDE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7ADB47-5849-D013-F4F4-AF57C151B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638BCA-7061-A050-7FD4-EA75204A1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38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5F6A41-E09E-AA43-2BF0-636AC07D52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7D355F-7067-8C67-D0E9-B467744CA1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779522-3735-268D-286C-E1CBCFFECF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12180-1A39-4F68-BD45-9C89F7AB37C6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6EA131-9829-19C3-22BB-AF50B86FB2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4F2499-9512-1895-B934-57E4DD7A2B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CE2C2-06BE-4E00-8ABD-F4FDAFCC1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05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1CF4949-C536-CD10-5111-53D006FBC2E0}"/>
              </a:ext>
            </a:extLst>
          </p:cNvPr>
          <p:cNvSpPr txBox="1"/>
          <p:nvPr/>
        </p:nvSpPr>
        <p:spPr>
          <a:xfrm>
            <a:off x="8058150" y="6400801"/>
            <a:ext cx="3552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nsari et al., Supplementary Fig. 1</a:t>
            </a:r>
          </a:p>
        </p:txBody>
      </p:sp>
      <p:pic>
        <p:nvPicPr>
          <p:cNvPr id="3073" name="Picture 2">
            <a:extLst>
              <a:ext uri="{FF2B5EF4-FFF2-40B4-BE49-F238E27FC236}">
                <a16:creationId xmlns:a16="http://schemas.microsoft.com/office/drawing/2014/main" id="{98D23C62-7AF4-433A-4762-8594A62DBE0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6450" y="661988"/>
            <a:ext cx="8039100" cy="55340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3">
            <a:extLst>
              <a:ext uri="{FF2B5EF4-FFF2-40B4-BE49-F238E27FC236}">
                <a16:creationId xmlns:a16="http://schemas.microsoft.com/office/drawing/2014/main" id="{7EF6911C-BC03-1D4D-619E-C42D1FC0C4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9912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2807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7" name="Picture 3">
            <a:extLst>
              <a:ext uri="{FF2B5EF4-FFF2-40B4-BE49-F238E27FC236}">
                <a16:creationId xmlns:a16="http://schemas.microsoft.com/office/drawing/2014/main" id="{A55F0801-8B09-09C5-2004-FCAE4F0384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261" y="619127"/>
            <a:ext cx="11983479" cy="56197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1FA206F7-DA3D-663D-F615-6C8AB32EAE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301609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88CB1B3-D210-A492-2BB9-8E4D8EE447FD}"/>
              </a:ext>
            </a:extLst>
          </p:cNvPr>
          <p:cNvSpPr txBox="1"/>
          <p:nvPr/>
        </p:nvSpPr>
        <p:spPr>
          <a:xfrm>
            <a:off x="8058150" y="6400801"/>
            <a:ext cx="4029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sari et al., Supplementary Fig. 2</a:t>
            </a:r>
          </a:p>
        </p:txBody>
      </p:sp>
    </p:spTree>
    <p:extLst>
      <p:ext uri="{BB962C8B-B14F-4D97-AF65-F5344CB8AC3E}">
        <p14:creationId xmlns:p14="http://schemas.microsoft.com/office/powerpoint/2010/main" val="31345824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8">
            <a:extLst>
              <a:ext uri="{FF2B5EF4-FFF2-40B4-BE49-F238E27FC236}">
                <a16:creationId xmlns:a16="http://schemas.microsoft.com/office/drawing/2014/main" id="{45B3648A-7AC0-0E07-B534-49ABD1B9660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9225" y="247650"/>
            <a:ext cx="6724650" cy="3438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1" name="Picture 4">
            <a:extLst>
              <a:ext uri="{FF2B5EF4-FFF2-40B4-BE49-F238E27FC236}">
                <a16:creationId xmlns:a16="http://schemas.microsoft.com/office/drawing/2014/main" id="{F2AA01BE-1184-510B-F252-AA911AF6F26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9225" y="3686175"/>
            <a:ext cx="6772275" cy="3171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D0D586C-8D35-3DEE-C7DA-39B71A1AA5E0}"/>
              </a:ext>
            </a:extLst>
          </p:cNvPr>
          <p:cNvSpPr txBox="1"/>
          <p:nvPr/>
        </p:nvSpPr>
        <p:spPr>
          <a:xfrm>
            <a:off x="8058150" y="6400801"/>
            <a:ext cx="3552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nsari et al., Supplementary Fig. 3</a:t>
            </a:r>
          </a:p>
        </p:txBody>
      </p:sp>
    </p:spTree>
    <p:extLst>
      <p:ext uri="{BB962C8B-B14F-4D97-AF65-F5344CB8AC3E}">
        <p14:creationId xmlns:p14="http://schemas.microsoft.com/office/powerpoint/2010/main" val="3680597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4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Texas A&amp;M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sari, Moiz Ashraf</dc:creator>
  <cp:lastModifiedBy>Ansari, Moiz Ashraf</cp:lastModifiedBy>
  <cp:revision>6</cp:revision>
  <dcterms:created xsi:type="dcterms:W3CDTF">2025-12-16T21:57:54Z</dcterms:created>
  <dcterms:modified xsi:type="dcterms:W3CDTF">2026-02-24T23:30:54Z</dcterms:modified>
</cp:coreProperties>
</file>